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9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21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2" d="100"/>
          <a:sy n="82" d="100"/>
        </p:scale>
        <p:origin x="1182" y="9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18DAAA-4309-4B5E-ACD7-AED8D6E0CB90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83CBBA-35D2-4D97-97E2-D7B083AB20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79799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529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5366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3764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2208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8139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512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792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3013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5166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1309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5682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D37FE-D28E-4A85-BC01-C7139EAE461B}" type="datetimeFigureOut">
              <a:rPr lang="de-DE" smtClean="0"/>
              <a:t>12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0C921-B6DB-4E9D-BF35-E4E762F31E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9777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elle 7">
            <a:extLst>
              <a:ext uri="{FF2B5EF4-FFF2-40B4-BE49-F238E27FC236}">
                <a16:creationId xmlns:a16="http://schemas.microsoft.com/office/drawing/2014/main" id="{B191E7F4-9DA2-4798-A1A5-D5752E313E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4921554"/>
              </p:ext>
            </p:extLst>
          </p:nvPr>
        </p:nvGraphicFramePr>
        <p:xfrm>
          <a:off x="235854" y="562482"/>
          <a:ext cx="6386292" cy="912017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10500">
                  <a:extLst>
                    <a:ext uri="{9D8B030D-6E8A-4147-A177-3AD203B41FA5}">
                      <a16:colId xmlns:a16="http://schemas.microsoft.com/office/drawing/2014/main" val="3180299941"/>
                    </a:ext>
                  </a:extLst>
                </a:gridCol>
                <a:gridCol w="476442">
                  <a:extLst>
                    <a:ext uri="{9D8B030D-6E8A-4147-A177-3AD203B41FA5}">
                      <a16:colId xmlns:a16="http://schemas.microsoft.com/office/drawing/2014/main" val="1707616452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920342020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2133994431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2676831915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1320945824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34417792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005287729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885470474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871404470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2918157578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38348299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789791992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2403166065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2698156346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4282160793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099075337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2714469806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13261482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680512627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1754036686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662707638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890627577"/>
                    </a:ext>
                  </a:extLst>
                </a:gridCol>
                <a:gridCol w="245425">
                  <a:extLst>
                    <a:ext uri="{9D8B030D-6E8A-4147-A177-3AD203B41FA5}">
                      <a16:colId xmlns:a16="http://schemas.microsoft.com/office/drawing/2014/main" val="3522693128"/>
                    </a:ext>
                  </a:extLst>
                </a:gridCol>
              </a:tblGrid>
              <a:tr h="156057">
                <a:tc>
                  <a:txBody>
                    <a:bodyPr/>
                    <a:lstStyle/>
                    <a:p>
                      <a:pPr algn="l" fontAlgn="b"/>
                      <a:r>
                        <a:rPr lang="de-DE" sz="650" u="none" strike="noStrike" dirty="0">
                          <a:effectLst/>
                        </a:rPr>
                        <a:t>Spearman-</a:t>
                      </a:r>
                      <a:r>
                        <a:rPr lang="de-DE" sz="650" u="none" strike="noStrike" dirty="0" err="1">
                          <a:effectLst/>
                        </a:rPr>
                        <a:t>rho</a:t>
                      </a:r>
                      <a:endParaRPr lang="de-DE" sz="65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QL2</a:t>
                      </a:r>
                      <a:endParaRPr lang="de-DE" sz="65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PF</a:t>
                      </a:r>
                      <a:endParaRPr lang="de-DE" sz="65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RF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EF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CF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SF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FA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NV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PA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DY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SL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AP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CO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DI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FI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BRBI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BRSEF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BRSEE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BRFU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BRST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BRBS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BRAS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476885241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 dirty="0" err="1">
                          <a:effectLst/>
                        </a:rPr>
                        <a:t>Physical</a:t>
                      </a:r>
                      <a:r>
                        <a:rPr lang="de-DE" sz="650" u="none" strike="noStrike" dirty="0">
                          <a:effectLst/>
                        </a:rPr>
                        <a:t> </a:t>
                      </a:r>
                      <a:r>
                        <a:rPr lang="de-DE" sz="650" u="none" strike="noStrike" dirty="0" err="1">
                          <a:effectLst/>
                        </a:rPr>
                        <a:t>functioning</a:t>
                      </a:r>
                      <a:r>
                        <a:rPr lang="de-DE" sz="650" u="none" strike="noStrike" dirty="0">
                          <a:effectLst/>
                        </a:rPr>
                        <a:t> (PF)</a:t>
                      </a:r>
                      <a:endParaRPr lang="de-DE" sz="65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37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046060030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00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694502379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Role functioning (RF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4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655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4262116778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605594670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Emotional functioning (EF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37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73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6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250519910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143061950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Cognitive functioning (CF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363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432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464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527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154644636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991266203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Social functioning (SF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66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345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565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577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58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4281546883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00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082079195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Fatigue (FA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1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683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708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2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,434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565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437960636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00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959687515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Nausea and vomiting (NV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21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9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4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7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21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96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93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733898317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6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48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6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00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577753921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Pain (PA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23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7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10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56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8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16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58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223</a:t>
                      </a:r>
                      <a:r>
                        <a:rPr lang="de-DE" sz="650" u="none" strike="noStrike" baseline="30000" dirty="0">
                          <a:effectLst/>
                        </a:rPr>
                        <a:t>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805086812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4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268092344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Dyspnoea (DY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9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610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516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44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9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34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529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257</a:t>
                      </a:r>
                      <a:r>
                        <a:rPr lang="de-DE" sz="650" u="none" strike="noStrike" baseline="30000" dirty="0">
                          <a:effectLst/>
                        </a:rPr>
                        <a:t>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375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069591460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04158188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Insomnia (SL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2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43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66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539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3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50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04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6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15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33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145890035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3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38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288553306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Appetite loss (AP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18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89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45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52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83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89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627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61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0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05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21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340319454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5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055941714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Constipation (CO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2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6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5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8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8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9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194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3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498300656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82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59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7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45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97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78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43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81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9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8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5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6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386810759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Diarrhoea (DI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82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98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2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4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60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2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9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6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14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141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4057900656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91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85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7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6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79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88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54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05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1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4165568320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Financial difficulties (FI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6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8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25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38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6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44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88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3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1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11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234</a:t>
                      </a:r>
                      <a:r>
                        <a:rPr lang="de-DE" sz="650" u="none" strike="noStrike" baseline="30000" dirty="0">
                          <a:effectLst/>
                        </a:rPr>
                        <a:t>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6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3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024255215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5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4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3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4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6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88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78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919279581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Body image (BRBI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49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63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1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30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6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17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76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2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6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67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66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7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5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33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988279968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7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3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138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99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66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148663361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Sexual functioning (BRSEF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1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4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1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39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7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3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2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1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9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162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142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8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04482100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7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2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1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96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84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3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1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4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86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2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8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5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21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92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9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604434002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Sexual enjoyment (BRSEE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5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6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2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8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6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5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31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6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7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9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105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6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135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3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0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674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623796629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7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43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54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69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76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88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8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3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43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71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65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61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44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51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51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1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362099146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Future perspective (BRFU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557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0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4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669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83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42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68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2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45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8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23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,240</a:t>
                      </a:r>
                      <a:r>
                        <a:rPr lang="de-DE" sz="650" u="none" strike="noStrike" baseline="30000" dirty="0">
                          <a:effectLst/>
                        </a:rPr>
                        <a:t>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7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56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54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57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2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5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029059752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6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53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63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8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45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413508101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en-US" sz="650" u="none" strike="noStrike">
                          <a:effectLst/>
                        </a:rPr>
                        <a:t>Systemic therapy side effects (BRST)</a:t>
                      </a:r>
                      <a:endParaRPr lang="en-US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74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00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14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99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59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14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69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98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50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99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48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297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69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358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,426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4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1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35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576401594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384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71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57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81936380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Breast symptoms (BRBS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58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2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3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93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66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21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1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5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5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2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51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4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026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45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81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220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140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2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90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59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623095031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6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4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1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5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9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63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7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7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81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52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218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92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2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945098632"/>
                  </a:ext>
                </a:extLst>
              </a:tr>
              <a:tr h="289156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Arm symptoms (BRAS)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20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22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7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8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223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1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40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66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8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5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7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04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028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288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,250</a:t>
                      </a:r>
                      <a:r>
                        <a:rPr lang="de-DE" sz="650" u="none" strike="noStrike" baseline="30000" dirty="0">
                          <a:effectLst/>
                        </a:rPr>
                        <a:t>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07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85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210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177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78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4752118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7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46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2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0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4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0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95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1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65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49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69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8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11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26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94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67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63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11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00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 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3932865400"/>
                  </a:ext>
                </a:extLst>
              </a:tr>
              <a:tr h="193815">
                <a:tc>
                  <a:txBody>
                    <a:bodyPr/>
                    <a:lstStyle/>
                    <a:p>
                      <a:pPr algn="l" fontAlgn="t"/>
                      <a:r>
                        <a:rPr lang="en-US" sz="650" u="none" strike="noStrike">
                          <a:effectLst/>
                        </a:rPr>
                        <a:t>Upset by hair loss (BRHL)</a:t>
                      </a:r>
                      <a:endParaRPr lang="en-US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 err="1"/>
                        <a:t>Correlation</a:t>
                      </a:r>
                      <a:r>
                        <a:rPr lang="de-DE" sz="650" dirty="0"/>
                        <a:t> </a:t>
                      </a:r>
                      <a:r>
                        <a:rPr lang="de-DE" sz="650" dirty="0" err="1"/>
                        <a:t>coefficient</a:t>
                      </a:r>
                      <a:endParaRPr lang="de-DE" sz="650" dirty="0"/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580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34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336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24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25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405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30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5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17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29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19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326</a:t>
                      </a:r>
                      <a:r>
                        <a:rPr lang="de-DE" sz="650" u="none" strike="noStrike" baseline="30000">
                          <a:effectLst/>
                        </a:rPr>
                        <a:t>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7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0,107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,435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-,556</a:t>
                      </a:r>
                      <a:r>
                        <a:rPr lang="de-DE" sz="650" u="none" strike="noStrike" baseline="30000">
                          <a:effectLst/>
                        </a:rPr>
                        <a:t>**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258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0,185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-,404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,457</a:t>
                      </a:r>
                      <a:r>
                        <a:rPr lang="de-DE" sz="650" u="none" strike="noStrike" baseline="30000" dirty="0">
                          <a:effectLst/>
                        </a:rPr>
                        <a:t>**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153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258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2239507146"/>
                  </a:ext>
                </a:extLst>
              </a:tr>
              <a:tr h="156057">
                <a:tc>
                  <a:txBody>
                    <a:bodyPr/>
                    <a:lstStyle/>
                    <a:p>
                      <a:pPr algn="l" fontAlgn="t"/>
                      <a:r>
                        <a:rPr lang="de-DE" sz="650" u="none" strike="noStrike">
                          <a:effectLst/>
                        </a:rPr>
                        <a:t> </a:t>
                      </a:r>
                      <a:endParaRPr lang="de-DE" sz="650" b="0" i="0" u="none" strike="noStrike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dirty="0"/>
                        <a:t>p</a:t>
                      </a: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1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1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0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8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52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1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41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56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3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35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637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499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4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>
                          <a:effectLst/>
                        </a:rPr>
                        <a:t>0,000</a:t>
                      </a:r>
                      <a:endParaRPr lang="de-DE" sz="65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99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508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08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002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332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50" u="none" strike="noStrike" dirty="0">
                          <a:effectLst/>
                        </a:rPr>
                        <a:t>0,100</a:t>
                      </a:r>
                      <a:endParaRPr lang="de-DE" sz="65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53" marR="3753" marT="3753" marB="0" anchor="ctr"/>
                </a:tc>
                <a:extLst>
                  <a:ext uri="{0D108BD9-81ED-4DB2-BD59-A6C34878D82A}">
                    <a16:rowId xmlns:a16="http://schemas.microsoft.com/office/drawing/2014/main" val="1091765946"/>
                  </a:ext>
                </a:extLst>
              </a:tr>
            </a:tbl>
          </a:graphicData>
        </a:graphic>
      </p:graphicFrame>
      <p:sp>
        <p:nvSpPr>
          <p:cNvPr id="4" name="Textfeld 1">
            <a:extLst>
              <a:ext uri="{FF2B5EF4-FFF2-40B4-BE49-F238E27FC236}">
                <a16:creationId xmlns:a16="http://schemas.microsoft.com/office/drawing/2014/main" id="{CE22DFE5-6AAE-4909-BF84-7C06FB01B077}"/>
              </a:ext>
            </a:extLst>
          </p:cNvPr>
          <p:cNvSpPr txBox="1"/>
          <p:nvPr/>
        </p:nvSpPr>
        <p:spPr>
          <a:xfrm>
            <a:off x="235854" y="38675"/>
            <a:ext cx="2682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/>
              <a:t>Supplemental</a:t>
            </a:r>
            <a:r>
              <a:rPr lang="de-DE" dirty="0"/>
              <a:t> </a:t>
            </a:r>
            <a:r>
              <a:rPr lang="de-DE" dirty="0"/>
              <a:t>Tabl</a:t>
            </a:r>
            <a:r>
              <a:rPr lang="de-DE" dirty="0"/>
              <a:t>e S2</a:t>
            </a:r>
          </a:p>
        </p:txBody>
      </p:sp>
    </p:spTree>
    <p:extLst>
      <p:ext uri="{BB962C8B-B14F-4D97-AF65-F5344CB8AC3E}">
        <p14:creationId xmlns:p14="http://schemas.microsoft.com/office/powerpoint/2010/main" val="3158515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27</Words>
  <Application>Microsoft Office PowerPoint</Application>
  <PresentationFormat>A4-Papier (210 x 297 mm)</PresentationFormat>
  <Paragraphs>108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atharina Dornieden</dc:creator>
  <cp:lastModifiedBy>Bartmann, Catharina</cp:lastModifiedBy>
  <cp:revision>210</cp:revision>
  <dcterms:created xsi:type="dcterms:W3CDTF">2021-01-15T22:32:37Z</dcterms:created>
  <dcterms:modified xsi:type="dcterms:W3CDTF">2021-12-12T21:04:02Z</dcterms:modified>
</cp:coreProperties>
</file>